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243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AFC6AD-8741-BFB0-4E6C-C8442B5581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A909449-B6B5-6C67-C3F5-46F590E2BE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9DC05CB-185D-1BD8-576B-FE307BD57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EE130F-7357-086A-38EB-6C2288E47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2DF2558-736F-9986-4AB5-6B039BD17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64144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EDC92B-85E1-8EF3-EA25-A2C23FE935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C7BE055-50CF-8C33-C171-4AF78B92D6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A6FD0AF-F126-83AE-844F-02E2503C90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6BC0FD7-4945-DF97-FC66-3B2F4ECF7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48F4E5-029F-568F-1E87-28A4DAC2B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041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BD49BBF-59BB-1FF4-F006-1BFE48529A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9EB98C2-D42B-78F6-461D-A8A0AE166B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8ED146-C494-DA39-8BAC-A63F78909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CE5F76D-09F7-C3D2-040E-2FB2AA6C4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4540E9-650F-B9E4-5855-ADDE1B9C1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0110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920007-5B8A-75AC-1B38-6070B2A512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CEAE029-EB55-BAB3-AE26-83E445B9C1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B2B5F9A-BE7E-7B86-D275-48F7440D5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662232-B50E-CD27-B6B2-572C275EF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E476F56-0657-E667-3EDB-4D811A854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0838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718319-5EBC-00C1-407F-57AB466BFA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5F28A7-3DF6-EE1A-5C11-F367B72FE1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7F268BB-C49B-7631-D1FA-2B2191AE0B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C3C7CB-B09C-37F8-3AFA-ACCEBC5F5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435F3D-3536-2022-6051-6AE6D50D1A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5577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BDA894-065B-A6D7-5BE4-63C05CC8F6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45252B3-B8B2-036C-3935-EFD39676EE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1A9FD85-B5C0-0EA1-838E-1A79CA92AC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017C7DB-68CE-E68C-EFDF-9408BCB3B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5D2E771-DD45-494D-9939-94618D35C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95F2ECB-7B52-ECC1-2541-6FC6B82C9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3362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ED5ED9-23F3-07C9-8394-D8B5BD4613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2990A87-4B17-FC19-501B-10186E6B04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B98688F-ACED-0542-895B-8A94C46A51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C4A6331-E43F-2E7D-A6FC-60E7BB6D3A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2757430-6968-5CDD-26BC-48F8FA24C5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2E94726-ABF6-88BB-6AA2-A54606365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ED671A2-CC29-1038-F07B-CAF6DFEBE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F11AFBF-7064-331A-0D95-DA896FA23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394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D56ACB-C696-AC57-3197-4906B5B171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B743034-01E2-13C6-F70C-21F4404D5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221A68D-13B8-5094-74A1-C9D33AD05C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1254632-3475-62B5-9069-2B8D15010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5478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70A89B2-FB89-FC35-D393-E318C6875E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0D3912B-E60B-8B78-E245-6B000A76D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CCE1078-AEF7-7DED-8801-777D2799D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8621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678D44-DB49-E883-FDFA-64B0060C85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D091A4B-F175-4C5F-0AEB-B108817D3A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E3FA243-FDDE-946E-45C7-B11BE17456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01D67B3-7529-4677-04FE-8E7A16639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F0F6131-2539-A5C7-AFD0-DB6314AF7D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277408D-4857-00DA-D341-8DF11B4749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110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06242B-6DB4-D7B1-42AC-C6633BF34B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2D78959-1135-3E49-ECD2-10B8E2B9F6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743262A-36E5-DED0-CA49-55C8CBEC42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992D9EA-16E5-6848-B20C-E43B4ABB12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4CB7E69-EA49-C389-D2BA-CAC7EADD2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AC776C7-B777-7EFF-D34B-432BAC4AA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2765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3149057-77DC-592C-1432-4C17137324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A970A55-02B0-232A-5E08-24793C2BBA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55EF5AC-EB4D-34A8-79CA-6CD59C1D74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884000-7931-4CF9-92F1-375531710214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61DFB56-0328-828A-A036-0C129B7B98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01E78A-D9BD-D309-7607-71FDF0E6BA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BE566A-7D0D-4CA5-9E74-0C9D2A88FB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544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id="{487A924C-0B95-BD40-3F4F-32B90472A8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0563422"/>
              </p:ext>
            </p:extLst>
          </p:nvPr>
        </p:nvGraphicFramePr>
        <p:xfrm>
          <a:off x="7015" y="227606"/>
          <a:ext cx="6838918" cy="926658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03568">
                  <a:extLst>
                    <a:ext uri="{9D8B030D-6E8A-4147-A177-3AD203B41FA5}">
                      <a16:colId xmlns:a16="http://schemas.microsoft.com/office/drawing/2014/main" val="2986735052"/>
                    </a:ext>
                  </a:extLst>
                </a:gridCol>
                <a:gridCol w="2658397">
                  <a:extLst>
                    <a:ext uri="{9D8B030D-6E8A-4147-A177-3AD203B41FA5}">
                      <a16:colId xmlns:a16="http://schemas.microsoft.com/office/drawing/2014/main" val="1634945780"/>
                    </a:ext>
                  </a:extLst>
                </a:gridCol>
                <a:gridCol w="574992">
                  <a:extLst>
                    <a:ext uri="{9D8B030D-6E8A-4147-A177-3AD203B41FA5}">
                      <a16:colId xmlns:a16="http://schemas.microsoft.com/office/drawing/2014/main" val="3633805689"/>
                    </a:ext>
                  </a:extLst>
                </a:gridCol>
                <a:gridCol w="443230">
                  <a:extLst>
                    <a:ext uri="{9D8B030D-6E8A-4147-A177-3AD203B41FA5}">
                      <a16:colId xmlns:a16="http://schemas.microsoft.com/office/drawing/2014/main" val="2240180366"/>
                    </a:ext>
                  </a:extLst>
                </a:gridCol>
                <a:gridCol w="403542">
                  <a:extLst>
                    <a:ext uri="{9D8B030D-6E8A-4147-A177-3AD203B41FA5}">
                      <a16:colId xmlns:a16="http://schemas.microsoft.com/office/drawing/2014/main" val="2573610804"/>
                    </a:ext>
                  </a:extLst>
                </a:gridCol>
                <a:gridCol w="1005205">
                  <a:extLst>
                    <a:ext uri="{9D8B030D-6E8A-4147-A177-3AD203B41FA5}">
                      <a16:colId xmlns:a16="http://schemas.microsoft.com/office/drawing/2014/main" val="3099658021"/>
                    </a:ext>
                  </a:extLst>
                </a:gridCol>
                <a:gridCol w="600392">
                  <a:extLst>
                    <a:ext uri="{9D8B030D-6E8A-4147-A177-3AD203B41FA5}">
                      <a16:colId xmlns:a16="http://schemas.microsoft.com/office/drawing/2014/main" val="2697512666"/>
                    </a:ext>
                  </a:extLst>
                </a:gridCol>
                <a:gridCol w="549592">
                  <a:extLst>
                    <a:ext uri="{9D8B030D-6E8A-4147-A177-3AD203B41FA5}">
                      <a16:colId xmlns:a16="http://schemas.microsoft.com/office/drawing/2014/main" val="3207419821"/>
                    </a:ext>
                  </a:extLst>
                </a:gridCol>
              </a:tblGrid>
              <a:tr h="47438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tif ID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tif logo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-value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rt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ery ID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main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nown</a:t>
                      </a:r>
                    </a:p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tif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1117705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tif_1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6e-18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64942947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1e-38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32613998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3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1e-40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7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157644341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4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1e-19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5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31303706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5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8e-84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6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1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loop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94192227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6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0e-74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27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7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78933675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7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e-12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7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9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89440869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8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.3e-45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0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4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16150871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9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4e-627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6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1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5508223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0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4e-27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2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46247368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8e-203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B-ARC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HD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44338370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2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6e-21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1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54897339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3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7e-34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2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6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04270617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4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9e-8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7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8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110379830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5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5e-22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9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3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93235494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6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5e-22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6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0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07897173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7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8e-113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1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3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213606417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8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0e-42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4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93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1621772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19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3e-27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9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3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32431135"/>
                  </a:ext>
                </a:extLst>
              </a:tr>
              <a:tr h="439610"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otif_20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9e-29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37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7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XP_004248174.1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RR</a:t>
                      </a:r>
                      <a:endParaRPr kumimoji="1" lang="ja-JP" altLang="en-US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45761831"/>
                  </a:ext>
                </a:extLst>
              </a:tr>
            </a:tbl>
          </a:graphicData>
        </a:graphic>
      </p:graphicFrame>
      <p:pic>
        <p:nvPicPr>
          <p:cNvPr id="2" name="Picture 2">
            <a:extLst>
              <a:ext uri="{FF2B5EF4-FFF2-40B4-BE49-F238E27FC236}">
                <a16:creationId xmlns:a16="http://schemas.microsoft.com/office/drawing/2014/main" id="{B5033B51-584F-E8C8-2592-287D8AD3E15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99" y="750141"/>
            <a:ext cx="1177201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4">
            <a:extLst>
              <a:ext uri="{FF2B5EF4-FFF2-40B4-BE49-F238E27FC236}">
                <a16:creationId xmlns:a16="http://schemas.microsoft.com/office/drawing/2014/main" id="{8CA3D519-16C9-00AE-D7C3-1C35CA21533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99" y="1189143"/>
            <a:ext cx="2690271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6">
            <a:extLst>
              <a:ext uri="{FF2B5EF4-FFF2-40B4-BE49-F238E27FC236}">
                <a16:creationId xmlns:a16="http://schemas.microsoft.com/office/drawing/2014/main" id="{4A1B778B-E683-9E38-F3DC-782C527D55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99" y="1628145"/>
            <a:ext cx="2690271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8">
            <a:extLst>
              <a:ext uri="{FF2B5EF4-FFF2-40B4-BE49-F238E27FC236}">
                <a16:creationId xmlns:a16="http://schemas.microsoft.com/office/drawing/2014/main" id="{204111E7-26BF-343E-6B2D-0E2A046BFD2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99" y="2067147"/>
            <a:ext cx="1177201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10">
            <a:extLst>
              <a:ext uri="{FF2B5EF4-FFF2-40B4-BE49-F238E27FC236}">
                <a16:creationId xmlns:a16="http://schemas.microsoft.com/office/drawing/2014/main" id="{89E3FEA8-53A2-AB7C-AC41-0B612C705C0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99" y="2506149"/>
            <a:ext cx="2690271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12">
            <a:extLst>
              <a:ext uri="{FF2B5EF4-FFF2-40B4-BE49-F238E27FC236}">
                <a16:creationId xmlns:a16="http://schemas.microsoft.com/office/drawing/2014/main" id="{AE9B1336-0AAA-C3C6-E785-9DF81562B0A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99" y="2945151"/>
            <a:ext cx="2690271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14">
            <a:extLst>
              <a:ext uri="{FF2B5EF4-FFF2-40B4-BE49-F238E27FC236}">
                <a16:creationId xmlns:a16="http://schemas.microsoft.com/office/drawing/2014/main" id="{E88806C8-D259-6628-940B-CF73B3A1C7B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99" y="3384153"/>
            <a:ext cx="1177201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6">
            <a:extLst>
              <a:ext uri="{FF2B5EF4-FFF2-40B4-BE49-F238E27FC236}">
                <a16:creationId xmlns:a16="http://schemas.microsoft.com/office/drawing/2014/main" id="{4319ADFE-72BB-3025-AB5E-9E65BFCF202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99" y="3823155"/>
            <a:ext cx="2219945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4BA6DA72-49A9-A28C-0B80-75CDD257E63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99" y="4262157"/>
            <a:ext cx="2690271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20">
            <a:extLst>
              <a:ext uri="{FF2B5EF4-FFF2-40B4-BE49-F238E27FC236}">
                <a16:creationId xmlns:a16="http://schemas.microsoft.com/office/drawing/2014/main" id="{D1CB50AA-B78F-6F90-12A9-AD8881194B9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99" y="4701159"/>
            <a:ext cx="1592569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224B9B78-78A0-3F87-0CFF-8529447629B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74899" y="5140161"/>
            <a:ext cx="1229023" cy="360000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4FF69146-2FBE-D0B7-DAAF-BD85D7AE760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74899" y="5579163"/>
            <a:ext cx="2218857" cy="3600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B36049B1-203E-B622-4061-376EE70ABDA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99" y="6018165"/>
            <a:ext cx="2690271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24">
            <a:extLst>
              <a:ext uri="{FF2B5EF4-FFF2-40B4-BE49-F238E27FC236}">
                <a16:creationId xmlns:a16="http://schemas.microsoft.com/office/drawing/2014/main" id="{000BA8CB-9856-FF4B-A7A3-A8D4FBDAC9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99" y="6457167"/>
            <a:ext cx="864206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0" name="Picture 26">
            <a:extLst>
              <a:ext uri="{FF2B5EF4-FFF2-40B4-BE49-F238E27FC236}">
                <a16:creationId xmlns:a16="http://schemas.microsoft.com/office/drawing/2014/main" id="{B7E5B045-B1E1-7078-9F77-1D74C1ECF09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99" y="6896169"/>
            <a:ext cx="2219945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1CB633AC-D771-EFC3-DF94-5754F4D2311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74899" y="7335171"/>
            <a:ext cx="2218857" cy="360000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F860782A-9922-6F77-507E-30CA8F12B2C0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74899" y="7774173"/>
            <a:ext cx="1593873" cy="360000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9C248174-693A-F4D7-D0ED-4BBADFF2BED5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74900" y="8213175"/>
            <a:ext cx="2688420" cy="360000"/>
          </a:xfrm>
          <a:prstGeom prst="rect">
            <a:avLst/>
          </a:prstGeom>
        </p:spPr>
      </p:pic>
      <p:pic>
        <p:nvPicPr>
          <p:cNvPr id="1052" name="Picture 28">
            <a:extLst>
              <a:ext uri="{FF2B5EF4-FFF2-40B4-BE49-F238E27FC236}">
                <a16:creationId xmlns:a16="http://schemas.microsoft.com/office/drawing/2014/main" id="{0386C211-F5B1-FFF8-DBB5-C91170AE361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99" y="8652177"/>
            <a:ext cx="2219945" cy="3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928988E0-5FA0-4BCA-9C2A-D460EAB59739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74900" y="9091171"/>
            <a:ext cx="2115245" cy="360000"/>
          </a:xfrm>
          <a:prstGeom prst="rect">
            <a:avLst/>
          </a:prstGeom>
        </p:spPr>
      </p:pic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C8F148A8-6108-681A-6FFA-CD63282DEC92}"/>
              </a:ext>
            </a:extLst>
          </p:cNvPr>
          <p:cNvSpPr/>
          <p:nvPr/>
        </p:nvSpPr>
        <p:spPr>
          <a:xfrm>
            <a:off x="902969" y="2505904"/>
            <a:ext cx="472441" cy="35999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F804A39D-BECC-7379-7D09-218773E92BC1}"/>
              </a:ext>
            </a:extLst>
          </p:cNvPr>
          <p:cNvSpPr/>
          <p:nvPr/>
        </p:nvSpPr>
        <p:spPr>
          <a:xfrm>
            <a:off x="898743" y="5145030"/>
            <a:ext cx="171868" cy="35999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テキスト ボックス 2">
            <a:extLst>
              <a:ext uri="{FF2B5EF4-FFF2-40B4-BE49-F238E27FC236}">
                <a16:creationId xmlns:a16="http://schemas.microsoft.com/office/drawing/2014/main" id="{136DC950-28E8-B808-7AAC-A13C5FEBCEFA}"/>
              </a:ext>
            </a:extLst>
          </p:cNvPr>
          <p:cNvSpPr txBox="1"/>
          <p:nvPr/>
        </p:nvSpPr>
        <p:spPr>
          <a:xfrm>
            <a:off x="0" y="-33333"/>
            <a:ext cx="45040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50" b="1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 Table S</a:t>
            </a:r>
            <a:r>
              <a:rPr lang="en-US" altLang="ja-JP" sz="105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5</a:t>
            </a:r>
            <a:r>
              <a:rPr lang="en-US" altLang="ja-JP" sz="1050" b="1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List of MEME motifs predicted </a:t>
            </a:r>
            <a:r>
              <a:rPr lang="en-US" altLang="ja-JP" sz="1050" b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rom NRC0-S.</a:t>
            </a:r>
            <a:endParaRPr lang="ja-JP" altLang="ja-JP" sz="1050" b="1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02547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</TotalTime>
  <Words>226</Words>
  <Application>Microsoft Office PowerPoint</Application>
  <PresentationFormat>A4 210 x 297 mm</PresentationFormat>
  <Paragraphs>1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shi</dc:creator>
  <cp:lastModifiedBy>Toshiyuki Sakai</cp:lastModifiedBy>
  <cp:revision>10</cp:revision>
  <dcterms:created xsi:type="dcterms:W3CDTF">2023-08-31T06:35:32Z</dcterms:created>
  <dcterms:modified xsi:type="dcterms:W3CDTF">2023-10-13T14:53:31Z</dcterms:modified>
</cp:coreProperties>
</file>